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4643"/>
  </p:normalViewPr>
  <p:slideViewPr>
    <p:cSldViewPr snapToGrid="0" snapToObjects="1">
      <p:cViewPr varScale="1">
        <p:scale>
          <a:sx n="128" d="100"/>
          <a:sy n="128" d="100"/>
        </p:scale>
        <p:origin x="48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4A1062-F557-4B46-AD4E-27EDDD11F8C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3D6BC82-89ED-2441-956A-3B7A0AD65C5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FB22168-E03F-BB4D-B945-3CC3D23CD087}"/>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5" name="Footer Placeholder 4">
            <a:extLst>
              <a:ext uri="{FF2B5EF4-FFF2-40B4-BE49-F238E27FC236}">
                <a16:creationId xmlns:a16="http://schemas.microsoft.com/office/drawing/2014/main" id="{70E9D2F6-E003-E64A-8398-0EAB593FAA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C9476A9-A95E-D449-BF9F-49EC850930E5}"/>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8441348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9FC2A8-7CDB-DF45-BFBB-94C41C5FD22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F215F10-5BA1-514F-BBC6-AEF61D6D9EA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F96D346-AD5D-AE45-B0C2-B548F6DDB2DF}"/>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5" name="Footer Placeholder 4">
            <a:extLst>
              <a:ext uri="{FF2B5EF4-FFF2-40B4-BE49-F238E27FC236}">
                <a16:creationId xmlns:a16="http://schemas.microsoft.com/office/drawing/2014/main" id="{5C29375C-731B-8843-9715-EA656A1386B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AB273A-B531-A844-9A10-9E98E8DCF434}"/>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23493944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9114291-C85F-9940-BDEC-FB774081A6C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CF9079B-1344-8C41-AFAF-D3CFCC0DF33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BAA4C24-A8B7-334E-831D-1022D8F74AA0}"/>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5" name="Footer Placeholder 4">
            <a:extLst>
              <a:ext uri="{FF2B5EF4-FFF2-40B4-BE49-F238E27FC236}">
                <a16:creationId xmlns:a16="http://schemas.microsoft.com/office/drawing/2014/main" id="{751891E1-4EB3-C449-84EC-08E2874645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79AB62-5C50-DB42-9165-239D97D2D3BE}"/>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26673329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997893-158A-7F4C-B18F-AFD3D9A12FE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347C1B9-3E70-FB4E-B968-2E5012805F0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B927AE-5B74-2A4B-86ED-FD5E43E02B45}"/>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5" name="Footer Placeholder 4">
            <a:extLst>
              <a:ext uri="{FF2B5EF4-FFF2-40B4-BE49-F238E27FC236}">
                <a16:creationId xmlns:a16="http://schemas.microsoft.com/office/drawing/2014/main" id="{0280B03E-F3EF-ED42-B24E-D32FAB788A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C26B98-5B5B-1D47-A597-06BC64FC334B}"/>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2335011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274282-3305-184B-8EF4-AAACF477397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507E832-73EF-9D46-9442-242246C7FE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C1A1497-110B-704F-8AB0-F5487FB24936}"/>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5" name="Footer Placeholder 4">
            <a:extLst>
              <a:ext uri="{FF2B5EF4-FFF2-40B4-BE49-F238E27FC236}">
                <a16:creationId xmlns:a16="http://schemas.microsoft.com/office/drawing/2014/main" id="{6ED4732E-9390-3841-B036-AD33B5A80B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E82B37E-7F7D-D34E-B3D4-F1DEA0E45509}"/>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17022795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70AD66-0835-274D-BF0A-755CFF68B13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E19DFC3-9276-914C-A00E-86CC8A1BFD0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E946456-0775-AA40-9687-296864CF92D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A87F434-5A5C-C044-9C1A-2F379FEFD8F2}"/>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6" name="Footer Placeholder 5">
            <a:extLst>
              <a:ext uri="{FF2B5EF4-FFF2-40B4-BE49-F238E27FC236}">
                <a16:creationId xmlns:a16="http://schemas.microsoft.com/office/drawing/2014/main" id="{81E88E1A-64C5-A144-8545-C48CD0C4864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B376EC1-8D9F-0341-BF8E-17FBA79FB061}"/>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38885540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604923-A439-8B43-A7C5-70382401530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BE5896D-911F-F34E-A26A-E0D169D1C0D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DB41A9D-8CB9-AF4E-8F5B-B6096D0E28E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83B16CA-E1E1-D64C-9665-FA6D0C3E5AD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FA551A1-92E5-AE41-9E14-400904A9C93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0136A46-765F-0048-A554-B861D5E06E1E}"/>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8" name="Footer Placeholder 7">
            <a:extLst>
              <a:ext uri="{FF2B5EF4-FFF2-40B4-BE49-F238E27FC236}">
                <a16:creationId xmlns:a16="http://schemas.microsoft.com/office/drawing/2014/main" id="{AC20F3FE-DC03-F34F-9995-4493EF6885A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A4BF859-579A-2E4C-ADB6-605938853690}"/>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24139266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4B647D-B54C-1443-8004-233FA70BB94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C6D3D09-57B7-5840-9263-085A790E0312}"/>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4" name="Footer Placeholder 3">
            <a:extLst>
              <a:ext uri="{FF2B5EF4-FFF2-40B4-BE49-F238E27FC236}">
                <a16:creationId xmlns:a16="http://schemas.microsoft.com/office/drawing/2014/main" id="{0D176342-AC5E-7740-8E0E-473899F33A8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A62CB03-FB6A-AE45-A9AE-43B5BCBA2DAC}"/>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31871740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0B371F8-3A7A-FB4D-AD80-CB98C6D08F4C}"/>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3" name="Footer Placeholder 2">
            <a:extLst>
              <a:ext uri="{FF2B5EF4-FFF2-40B4-BE49-F238E27FC236}">
                <a16:creationId xmlns:a16="http://schemas.microsoft.com/office/drawing/2014/main" id="{300F1767-C311-3E4B-A97E-CF242BE3200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307CFA9-458F-7946-BB95-1242112F1827}"/>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24324416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C3117-8C7F-964D-9569-692085D82AF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CC76C93-223F-7F42-91D8-267975CD70A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97E2048-BE38-6448-B56A-CAF0086C852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A89CEFE-7803-F947-A34F-B8D3BEBACEBC}"/>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6" name="Footer Placeholder 5">
            <a:extLst>
              <a:ext uri="{FF2B5EF4-FFF2-40B4-BE49-F238E27FC236}">
                <a16:creationId xmlns:a16="http://schemas.microsoft.com/office/drawing/2014/main" id="{784F800C-6203-B946-B310-ECA6E471315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2FA6E44-AD15-D84F-AEA6-C313C1F0B113}"/>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4454162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7ED780-804F-5941-B04D-773E77FC2A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063DD44-63C8-DF41-A6A3-4B58CA2C0E0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7BC21B6-CE0D-2841-8B62-E89AAFD075E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BE2333A-9175-8741-801A-DCD307A2CADA}"/>
              </a:ext>
            </a:extLst>
          </p:cNvPr>
          <p:cNvSpPr>
            <a:spLocks noGrp="1"/>
          </p:cNvSpPr>
          <p:nvPr>
            <p:ph type="dt" sz="half" idx="10"/>
          </p:nvPr>
        </p:nvSpPr>
        <p:spPr/>
        <p:txBody>
          <a:bodyPr/>
          <a:lstStyle/>
          <a:p>
            <a:fld id="{C76DFE49-DEE7-8C4E-8902-47FFA6A2EB2C}" type="datetimeFigureOut">
              <a:rPr lang="en-US" smtClean="0"/>
              <a:t>3/3/22</a:t>
            </a:fld>
            <a:endParaRPr lang="en-US"/>
          </a:p>
        </p:txBody>
      </p:sp>
      <p:sp>
        <p:nvSpPr>
          <p:cNvPr id="6" name="Footer Placeholder 5">
            <a:extLst>
              <a:ext uri="{FF2B5EF4-FFF2-40B4-BE49-F238E27FC236}">
                <a16:creationId xmlns:a16="http://schemas.microsoft.com/office/drawing/2014/main" id="{F17FF771-1A53-8147-A4BE-14A86E040E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8A9C2D5-E204-EC4F-A6D0-6E76600D6C30}"/>
              </a:ext>
            </a:extLst>
          </p:cNvPr>
          <p:cNvSpPr>
            <a:spLocks noGrp="1"/>
          </p:cNvSpPr>
          <p:nvPr>
            <p:ph type="sldNum" sz="quarter" idx="12"/>
          </p:nvPr>
        </p:nvSpPr>
        <p:spPr/>
        <p:txBody>
          <a:bodyPr/>
          <a:lstStyle/>
          <a:p>
            <a:fld id="{CFE0C601-C754-5146-BD9B-86F5A30DB88B}" type="slidenum">
              <a:rPr lang="en-US" smtClean="0"/>
              <a:t>‹#›</a:t>
            </a:fld>
            <a:endParaRPr lang="en-US"/>
          </a:p>
        </p:txBody>
      </p:sp>
    </p:spTree>
    <p:extLst>
      <p:ext uri="{BB962C8B-B14F-4D97-AF65-F5344CB8AC3E}">
        <p14:creationId xmlns:p14="http://schemas.microsoft.com/office/powerpoint/2010/main" val="16926950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7B51E86-18A9-AE48-975B-8D34F446328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E8C5982-5D57-4946-9FAC-0CACF96E621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C599FE-C0DF-B34C-A901-55777B7DEC0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6DFE49-DEE7-8C4E-8902-47FFA6A2EB2C}" type="datetimeFigureOut">
              <a:rPr lang="en-US" smtClean="0"/>
              <a:t>3/3/22</a:t>
            </a:fld>
            <a:endParaRPr lang="en-US"/>
          </a:p>
        </p:txBody>
      </p:sp>
      <p:sp>
        <p:nvSpPr>
          <p:cNvPr id="5" name="Footer Placeholder 4">
            <a:extLst>
              <a:ext uri="{FF2B5EF4-FFF2-40B4-BE49-F238E27FC236}">
                <a16:creationId xmlns:a16="http://schemas.microsoft.com/office/drawing/2014/main" id="{1C01D00B-789F-9142-9DB2-8C96FDFF808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F204CFF-71D5-D44D-8C4E-4683C3440DD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FE0C601-C754-5146-BD9B-86F5A30DB88B}" type="slidenum">
              <a:rPr lang="en-US" smtClean="0"/>
              <a:t>‹#›</a:t>
            </a:fld>
            <a:endParaRPr lang="en-US"/>
          </a:p>
        </p:txBody>
      </p:sp>
    </p:spTree>
    <p:extLst>
      <p:ext uri="{BB962C8B-B14F-4D97-AF65-F5344CB8AC3E}">
        <p14:creationId xmlns:p14="http://schemas.microsoft.com/office/powerpoint/2010/main" val="36553821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032CD9F-ACC9-234B-9BB2-50B415246522}"/>
              </a:ext>
            </a:extLst>
          </p:cNvPr>
          <p:cNvPicPr>
            <a:picLocks noChangeAspect="1"/>
          </p:cNvPicPr>
          <p:nvPr/>
        </p:nvPicPr>
        <p:blipFill>
          <a:blip r:embed="rId2"/>
          <a:stretch>
            <a:fillRect/>
          </a:stretch>
        </p:blipFill>
        <p:spPr>
          <a:xfrm>
            <a:off x="927100" y="775252"/>
            <a:ext cx="10337800" cy="4762500"/>
          </a:xfrm>
          <a:prstGeom prst="rect">
            <a:avLst/>
          </a:prstGeom>
        </p:spPr>
      </p:pic>
      <p:sp>
        <p:nvSpPr>
          <p:cNvPr id="2" name="TextBox 1">
            <a:extLst>
              <a:ext uri="{FF2B5EF4-FFF2-40B4-BE49-F238E27FC236}">
                <a16:creationId xmlns:a16="http://schemas.microsoft.com/office/drawing/2014/main" id="{E9217823-ECB9-D743-A014-210D74ABD776}"/>
              </a:ext>
            </a:extLst>
          </p:cNvPr>
          <p:cNvSpPr txBox="1"/>
          <p:nvPr/>
        </p:nvSpPr>
        <p:spPr>
          <a:xfrm>
            <a:off x="89452" y="313587"/>
            <a:ext cx="2619628" cy="461665"/>
          </a:xfrm>
          <a:prstGeom prst="rect">
            <a:avLst/>
          </a:prstGeom>
          <a:noFill/>
        </p:spPr>
        <p:txBody>
          <a:bodyPr wrap="none" rtlCol="0">
            <a:spAutoFit/>
          </a:bodyPr>
          <a:lstStyle/>
          <a:p>
            <a:r>
              <a:rPr lang="en-US" sz="2400" b="1" dirty="0">
                <a:latin typeface="Times New Roman" panose="02020603050405020304" pitchFamily="18" charset="0"/>
                <a:cs typeface="Times New Roman" panose="02020603050405020304" pitchFamily="18" charset="0"/>
              </a:rPr>
              <a:t>Additional File 10 </a:t>
            </a:r>
          </a:p>
        </p:txBody>
      </p:sp>
      <p:sp>
        <p:nvSpPr>
          <p:cNvPr id="4" name="TextBox 3">
            <a:extLst>
              <a:ext uri="{FF2B5EF4-FFF2-40B4-BE49-F238E27FC236}">
                <a16:creationId xmlns:a16="http://schemas.microsoft.com/office/drawing/2014/main" id="{219EC40E-2803-FA42-AE2B-350C0891E251}"/>
              </a:ext>
            </a:extLst>
          </p:cNvPr>
          <p:cNvSpPr txBox="1"/>
          <p:nvPr/>
        </p:nvSpPr>
        <p:spPr>
          <a:xfrm>
            <a:off x="341243" y="5539408"/>
            <a:ext cx="11509513" cy="1200329"/>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Speed improvement strategy example. A) The full edit distance matrix table, comprised of 81 computations. B) The abbreviated edit distance matrix table, comprised of 46 computations. The two identical leading bases were removed from the analysis. Two expected errors and one allowed frameshift position result in a matrix width of 3. The SLD is shown in green and is preserved. </a:t>
            </a:r>
          </a:p>
        </p:txBody>
      </p:sp>
    </p:spTree>
    <p:extLst>
      <p:ext uri="{BB962C8B-B14F-4D97-AF65-F5344CB8AC3E}">
        <p14:creationId xmlns:p14="http://schemas.microsoft.com/office/powerpoint/2010/main" val="395047019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73</Words>
  <Application>Microsoft Macintosh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ert Logan</dc:creator>
  <cp:lastModifiedBy>Robert Logan</cp:lastModifiedBy>
  <cp:revision>2</cp:revision>
  <dcterms:created xsi:type="dcterms:W3CDTF">2019-12-13T17:04:05Z</dcterms:created>
  <dcterms:modified xsi:type="dcterms:W3CDTF">2022-03-03T20:06:11Z</dcterms:modified>
</cp:coreProperties>
</file>